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6" r:id="rId2"/>
    <p:sldId id="277" r:id="rId3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51D5E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llanmörkt format 2 - Dekorfärg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Inget format, tabellrutnät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5610"/>
    <p:restoredTop sz="96281"/>
  </p:normalViewPr>
  <p:slideViewPr>
    <p:cSldViewPr snapToGrid="0" snapToObjects="1">
      <p:cViewPr varScale="1">
        <p:scale>
          <a:sx n="94" d="100"/>
          <a:sy n="94" d="100"/>
        </p:scale>
        <p:origin x="200" y="8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DCFA93E3-BB5C-B94E-A5B9-4B079324413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Underrubrik 2">
            <a:extLst>
              <a:ext uri="{FF2B5EF4-FFF2-40B4-BE49-F238E27FC236}">
                <a16:creationId xmlns:a16="http://schemas.microsoft.com/office/drawing/2014/main" id="{3CB15FD8-DC1E-0346-9916-C12D35D7BA7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/>
              <a:t>Klicka här för att ändra mall för underrubrikformat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4CB6048C-98A4-5540-8D5D-7D8C433324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C6E048-8F7B-4A48-98B8-51D7D109A877}" type="datetimeFigureOut">
              <a:rPr lang="sv-SE" smtClean="0"/>
              <a:t>2022-04-23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E283A2DC-F6C1-6F4F-826F-672C3D7530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9A5DFA9B-2300-DE4D-946A-43924E5A59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132A7D-411C-D240-BC22-2DA585EEBF0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3952463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BAEF11A1-C773-AF4D-B78E-086024FBA8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B7F2DFAA-F2F5-2A47-BE4B-B8A5AAC79A6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CC074ADE-A4B3-F848-B294-AB1CD17C1E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C6E048-8F7B-4A48-98B8-51D7D109A877}" type="datetimeFigureOut">
              <a:rPr lang="sv-SE" smtClean="0"/>
              <a:t>2022-04-23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1DF96BB5-0609-AD4D-9EF3-C8CBF27A29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9D70F91D-F3D3-2D44-B9E9-E86753BDBE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132A7D-411C-D240-BC22-2DA585EEBF0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0964391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>
            <a:extLst>
              <a:ext uri="{FF2B5EF4-FFF2-40B4-BE49-F238E27FC236}">
                <a16:creationId xmlns:a16="http://schemas.microsoft.com/office/drawing/2014/main" id="{C89DE513-F05E-2C44-9A22-80707071FF0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682D769C-BB4B-3D41-9BD6-DCF9B6BAD6A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05A69350-49BA-A44F-9BA9-62EF2CD8CC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C6E048-8F7B-4A48-98B8-51D7D109A877}" type="datetimeFigureOut">
              <a:rPr lang="sv-SE" smtClean="0"/>
              <a:t>2022-04-23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B04756CB-4352-3B4A-8C82-5C7DAEC28A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F674E43D-B9A7-304F-B531-CC67865188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132A7D-411C-D240-BC22-2DA585EEBF0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9013980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2D77D790-5BAD-BF4A-AAC3-A9CDB75826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BDCB4611-138C-4E48-B8DC-4B35015587A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929C6FBA-A7CC-5845-AF10-A9E9AEFD3F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C6E048-8F7B-4A48-98B8-51D7D109A877}" type="datetimeFigureOut">
              <a:rPr lang="sv-SE" smtClean="0"/>
              <a:t>2022-04-23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F3CE500B-8F8D-214E-BE9D-485CA41A11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C8B87C77-E60A-784D-BC84-E834846705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132A7D-411C-D240-BC22-2DA585EEBF0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232208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2243F8D4-608D-3240-B7D0-B666084B7A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00291C1C-F3AE-3946-8853-2869C73A22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D7CEC759-B71E-5546-BD1C-4CCD7BD336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C6E048-8F7B-4A48-98B8-51D7D109A877}" type="datetimeFigureOut">
              <a:rPr lang="sv-SE" smtClean="0"/>
              <a:t>2022-04-23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356A9B10-DB94-B44D-8064-6B0E2C60A1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CDE51093-3913-C440-89E1-F7203B1B9B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132A7D-411C-D240-BC22-2DA585EEBF0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4929603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0EDCE1DC-18E3-F64F-A11C-0E4B0C12CD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493C525A-13A4-4A44-AA8D-CA26C004E4D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73DFDCCE-EF13-4943-B6F2-B2068F10D14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46BA2030-9FA5-9A4A-A392-A1585B43A5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C6E048-8F7B-4A48-98B8-51D7D109A877}" type="datetimeFigureOut">
              <a:rPr lang="sv-SE" smtClean="0"/>
              <a:t>2022-04-23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98ECDB40-0D83-DB41-BD3C-D67B07F934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F05C4F90-FEF8-4D4F-B38E-FFADA42471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132A7D-411C-D240-BC22-2DA585EEBF0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708055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59821AA2-7D0D-144E-99AB-66E258AFDE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9732E1BA-DF7B-6949-B793-651533B8F0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A6ADB4FA-4D58-BD4A-B517-33C98D3461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text 4">
            <a:extLst>
              <a:ext uri="{FF2B5EF4-FFF2-40B4-BE49-F238E27FC236}">
                <a16:creationId xmlns:a16="http://schemas.microsoft.com/office/drawing/2014/main" id="{4F955CBB-7771-7F4D-B882-DC27E35C7F9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6" name="Platshållare för innehåll 5">
            <a:extLst>
              <a:ext uri="{FF2B5EF4-FFF2-40B4-BE49-F238E27FC236}">
                <a16:creationId xmlns:a16="http://schemas.microsoft.com/office/drawing/2014/main" id="{CB250C6D-3E05-9640-9DDF-8D80CCEE811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7" name="Platshållare för datum 6">
            <a:extLst>
              <a:ext uri="{FF2B5EF4-FFF2-40B4-BE49-F238E27FC236}">
                <a16:creationId xmlns:a16="http://schemas.microsoft.com/office/drawing/2014/main" id="{C0B7C851-2BAB-F847-B00A-F33F353207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C6E048-8F7B-4A48-98B8-51D7D109A877}" type="datetimeFigureOut">
              <a:rPr lang="sv-SE" smtClean="0"/>
              <a:t>2022-04-23</a:t>
            </a:fld>
            <a:endParaRPr lang="sv-SE"/>
          </a:p>
        </p:txBody>
      </p:sp>
      <p:sp>
        <p:nvSpPr>
          <p:cNvPr id="8" name="Platshållare för sidfot 7">
            <a:extLst>
              <a:ext uri="{FF2B5EF4-FFF2-40B4-BE49-F238E27FC236}">
                <a16:creationId xmlns:a16="http://schemas.microsoft.com/office/drawing/2014/main" id="{057F5E7F-478E-7749-BE5C-4A193EB790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>
            <a:extLst>
              <a:ext uri="{FF2B5EF4-FFF2-40B4-BE49-F238E27FC236}">
                <a16:creationId xmlns:a16="http://schemas.microsoft.com/office/drawing/2014/main" id="{6C3D231D-C30C-2E41-ABEB-A8C53CEF4E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132A7D-411C-D240-BC22-2DA585EEBF0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1551344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652B3ABA-B61C-9D4E-B237-A4A81ABA1E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datum 2">
            <a:extLst>
              <a:ext uri="{FF2B5EF4-FFF2-40B4-BE49-F238E27FC236}">
                <a16:creationId xmlns:a16="http://schemas.microsoft.com/office/drawing/2014/main" id="{91F8AB7E-678B-B84D-A01A-E7551428DA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C6E048-8F7B-4A48-98B8-51D7D109A877}" type="datetimeFigureOut">
              <a:rPr lang="sv-SE" smtClean="0"/>
              <a:t>2022-04-23</a:t>
            </a:fld>
            <a:endParaRPr lang="sv-SE"/>
          </a:p>
        </p:txBody>
      </p:sp>
      <p:sp>
        <p:nvSpPr>
          <p:cNvPr id="4" name="Platshållare för sidfot 3">
            <a:extLst>
              <a:ext uri="{FF2B5EF4-FFF2-40B4-BE49-F238E27FC236}">
                <a16:creationId xmlns:a16="http://schemas.microsoft.com/office/drawing/2014/main" id="{E681AEAD-0158-2146-81A8-14C4CA8FA8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>
            <a:extLst>
              <a:ext uri="{FF2B5EF4-FFF2-40B4-BE49-F238E27FC236}">
                <a16:creationId xmlns:a16="http://schemas.microsoft.com/office/drawing/2014/main" id="{C8370B86-F111-E748-9BDA-195FE30EFE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132A7D-411C-D240-BC22-2DA585EEBF0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5857582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>
            <a:extLst>
              <a:ext uri="{FF2B5EF4-FFF2-40B4-BE49-F238E27FC236}">
                <a16:creationId xmlns:a16="http://schemas.microsoft.com/office/drawing/2014/main" id="{2D5E35E5-2347-5246-84D6-FFF61694D6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C6E048-8F7B-4A48-98B8-51D7D109A877}" type="datetimeFigureOut">
              <a:rPr lang="sv-SE" smtClean="0"/>
              <a:t>2022-04-23</a:t>
            </a:fld>
            <a:endParaRPr lang="sv-SE"/>
          </a:p>
        </p:txBody>
      </p:sp>
      <p:sp>
        <p:nvSpPr>
          <p:cNvPr id="3" name="Platshållare för sidfot 2">
            <a:extLst>
              <a:ext uri="{FF2B5EF4-FFF2-40B4-BE49-F238E27FC236}">
                <a16:creationId xmlns:a16="http://schemas.microsoft.com/office/drawing/2014/main" id="{D5F75867-A4C8-CC4E-A563-9E3A903358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>
            <a:extLst>
              <a:ext uri="{FF2B5EF4-FFF2-40B4-BE49-F238E27FC236}">
                <a16:creationId xmlns:a16="http://schemas.microsoft.com/office/drawing/2014/main" id="{9EFF872F-7A87-AE4E-AD65-0D66247403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132A7D-411C-D240-BC22-2DA585EEBF0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9302185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ext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39E6E909-4A66-0643-92F1-48A864D4BF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C5BFF3B7-2731-7C44-B525-D15B82A49E8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CB3F0CAF-08F5-A043-94B3-31195576309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1E8EEF12-6FF0-1644-A46E-2B402C0CCA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C6E048-8F7B-4A48-98B8-51D7D109A877}" type="datetimeFigureOut">
              <a:rPr lang="sv-SE" smtClean="0"/>
              <a:t>2022-04-23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26B3098C-6B68-A447-9B5A-95215CD0AF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DA316C6C-3A2D-7847-8A35-5970ACA840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132A7D-411C-D240-BC22-2DA585EEBF0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3462299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7D17559D-0233-B74F-863F-B885FC7055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bild 2">
            <a:extLst>
              <a:ext uri="{FF2B5EF4-FFF2-40B4-BE49-F238E27FC236}">
                <a16:creationId xmlns:a16="http://schemas.microsoft.com/office/drawing/2014/main" id="{16EA53D0-A2F9-F74E-A7D0-D510F5AE1A1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7F87B81D-3DAE-1147-BB79-D597040E5C9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5E37409E-8918-7044-BBAC-4857078C0D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C6E048-8F7B-4A48-98B8-51D7D109A877}" type="datetimeFigureOut">
              <a:rPr lang="sv-SE" smtClean="0"/>
              <a:t>2022-04-23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D824784D-5F3F-0946-AA7A-A894F006E4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6FAF27BA-7CA7-194F-A35A-3054933B04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132A7D-411C-D240-BC22-2DA585EEBF0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2113333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>
            <a:extLst>
              <a:ext uri="{FF2B5EF4-FFF2-40B4-BE49-F238E27FC236}">
                <a16:creationId xmlns:a16="http://schemas.microsoft.com/office/drawing/2014/main" id="{CCEC5367-261F-1744-80D0-E98B778A44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919A98F7-9CF3-2E4F-AF4E-B74E5163AB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C8D0ECD2-FEA9-DC43-95B6-4B886488C87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C6E048-8F7B-4A48-98B8-51D7D109A877}" type="datetimeFigureOut">
              <a:rPr lang="sv-SE" smtClean="0"/>
              <a:t>2022-04-23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C81E62C2-C9D4-A44B-85D7-01BEA52B9BC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FFD4C1C6-5A4E-794C-95CA-D27B7F7C2C1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132A7D-411C-D240-BC22-2DA585EEBF0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0421548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 4">
            <a:extLst>
              <a:ext uri="{FF2B5EF4-FFF2-40B4-BE49-F238E27FC236}">
                <a16:creationId xmlns:a16="http://schemas.microsoft.com/office/drawing/2014/main" id="{279B11B5-1C52-744C-B502-FFDC4478F7F2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58257457"/>
              </p:ext>
            </p:extLst>
          </p:nvPr>
        </p:nvGraphicFramePr>
        <p:xfrm>
          <a:off x="505968" y="89300"/>
          <a:ext cx="10698326" cy="66794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524000">
                  <a:extLst>
                    <a:ext uri="{9D8B030D-6E8A-4147-A177-3AD203B41FA5}">
                      <a16:colId xmlns:a16="http://schemas.microsoft.com/office/drawing/2014/main" val="1080027653"/>
                    </a:ext>
                  </a:extLst>
                </a:gridCol>
                <a:gridCol w="548640">
                  <a:extLst>
                    <a:ext uri="{9D8B030D-6E8A-4147-A177-3AD203B41FA5}">
                      <a16:colId xmlns:a16="http://schemas.microsoft.com/office/drawing/2014/main" val="3933771790"/>
                    </a:ext>
                  </a:extLst>
                </a:gridCol>
                <a:gridCol w="560832">
                  <a:extLst>
                    <a:ext uri="{9D8B030D-6E8A-4147-A177-3AD203B41FA5}">
                      <a16:colId xmlns:a16="http://schemas.microsoft.com/office/drawing/2014/main" val="3010879176"/>
                    </a:ext>
                  </a:extLst>
                </a:gridCol>
                <a:gridCol w="573024">
                  <a:extLst>
                    <a:ext uri="{9D8B030D-6E8A-4147-A177-3AD203B41FA5}">
                      <a16:colId xmlns:a16="http://schemas.microsoft.com/office/drawing/2014/main" val="1579781944"/>
                    </a:ext>
                  </a:extLst>
                </a:gridCol>
                <a:gridCol w="585216">
                  <a:extLst>
                    <a:ext uri="{9D8B030D-6E8A-4147-A177-3AD203B41FA5}">
                      <a16:colId xmlns:a16="http://schemas.microsoft.com/office/drawing/2014/main" val="292175835"/>
                    </a:ext>
                  </a:extLst>
                </a:gridCol>
                <a:gridCol w="560832">
                  <a:extLst>
                    <a:ext uri="{9D8B030D-6E8A-4147-A177-3AD203B41FA5}">
                      <a16:colId xmlns:a16="http://schemas.microsoft.com/office/drawing/2014/main" val="1377415389"/>
                    </a:ext>
                  </a:extLst>
                </a:gridCol>
                <a:gridCol w="597408">
                  <a:extLst>
                    <a:ext uri="{9D8B030D-6E8A-4147-A177-3AD203B41FA5}">
                      <a16:colId xmlns:a16="http://schemas.microsoft.com/office/drawing/2014/main" val="353620893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315356964"/>
                    </a:ext>
                  </a:extLst>
                </a:gridCol>
                <a:gridCol w="597408">
                  <a:extLst>
                    <a:ext uri="{9D8B030D-6E8A-4147-A177-3AD203B41FA5}">
                      <a16:colId xmlns:a16="http://schemas.microsoft.com/office/drawing/2014/main" val="293044056"/>
                    </a:ext>
                  </a:extLst>
                </a:gridCol>
                <a:gridCol w="573024">
                  <a:extLst>
                    <a:ext uri="{9D8B030D-6E8A-4147-A177-3AD203B41FA5}">
                      <a16:colId xmlns:a16="http://schemas.microsoft.com/office/drawing/2014/main" val="3527300219"/>
                    </a:ext>
                  </a:extLst>
                </a:gridCol>
                <a:gridCol w="621792">
                  <a:extLst>
                    <a:ext uri="{9D8B030D-6E8A-4147-A177-3AD203B41FA5}">
                      <a16:colId xmlns:a16="http://schemas.microsoft.com/office/drawing/2014/main" val="2571088742"/>
                    </a:ext>
                  </a:extLst>
                </a:gridCol>
                <a:gridCol w="621792">
                  <a:extLst>
                    <a:ext uri="{9D8B030D-6E8A-4147-A177-3AD203B41FA5}">
                      <a16:colId xmlns:a16="http://schemas.microsoft.com/office/drawing/2014/main" val="1049949130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163118114"/>
                    </a:ext>
                  </a:extLst>
                </a:gridCol>
                <a:gridCol w="621792">
                  <a:extLst>
                    <a:ext uri="{9D8B030D-6E8A-4147-A177-3AD203B41FA5}">
                      <a16:colId xmlns:a16="http://schemas.microsoft.com/office/drawing/2014/main" val="4071078523"/>
                    </a:ext>
                  </a:extLst>
                </a:gridCol>
                <a:gridCol w="658368">
                  <a:extLst>
                    <a:ext uri="{9D8B030D-6E8A-4147-A177-3AD203B41FA5}">
                      <a16:colId xmlns:a16="http://schemas.microsoft.com/office/drawing/2014/main" val="1082466764"/>
                    </a:ext>
                  </a:extLst>
                </a:gridCol>
                <a:gridCol w="834998">
                  <a:extLst>
                    <a:ext uri="{9D8B030D-6E8A-4147-A177-3AD203B41FA5}">
                      <a16:colId xmlns:a16="http://schemas.microsoft.com/office/drawing/2014/main" val="1707747465"/>
                    </a:ext>
                  </a:extLst>
                </a:gridCol>
              </a:tblGrid>
              <a:tr h="370840">
                <a:tc gridSpan="16">
                  <a:txBody>
                    <a:bodyPr/>
                    <a:lstStyle/>
                    <a:p>
                      <a:pPr algn="l"/>
                      <a:r>
                        <a:rPr lang="sv-SE" sz="9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pplementary</a:t>
                      </a:r>
                      <a:r>
                        <a:rPr lang="sv-SE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Table S2. </a:t>
                      </a:r>
                      <a:r>
                        <a:rPr lang="sv-SE" sz="900" b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uality</a:t>
                      </a:r>
                      <a:r>
                        <a:rPr lang="sv-SE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sv-SE" sz="900" b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sessment</a:t>
                      </a:r>
                      <a:r>
                        <a:rPr lang="sv-SE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sv-SE" sz="900" b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f</a:t>
                      </a:r>
                      <a:r>
                        <a:rPr lang="sv-SE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sv-SE" sz="900" b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cluded</a:t>
                      </a:r>
                      <a:r>
                        <a:rPr lang="sv-SE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sv-SE" sz="900" b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hort</a:t>
                      </a:r>
                      <a:r>
                        <a:rPr lang="sv-SE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nd Cross-</a:t>
                      </a:r>
                      <a:r>
                        <a:rPr lang="sv-SE" sz="900" b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ctional</a:t>
                      </a:r>
                      <a:r>
                        <a:rPr lang="sv-SE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tudies.</a:t>
                      </a:r>
                      <a:endParaRPr lang="sv-SE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/>
                      <a:endParaRPr lang="sv-SE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b"/>
                </a:tc>
                <a:extLst>
                  <a:ext uri="{0D108BD9-81ED-4DB2-BD59-A6C34878D82A}">
                    <a16:rowId xmlns:a16="http://schemas.microsoft.com/office/drawing/2014/main" val="351817335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udy Author(s) (Year)</a:t>
                      </a: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1</a:t>
                      </a: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2</a:t>
                      </a: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3</a:t>
                      </a: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4</a:t>
                      </a: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5</a:t>
                      </a: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6</a:t>
                      </a: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7</a:t>
                      </a: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8</a:t>
                      </a: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9</a:t>
                      </a: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10</a:t>
                      </a: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11</a:t>
                      </a: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12</a:t>
                      </a: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13</a:t>
                      </a: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14</a:t>
                      </a: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udy</a:t>
                      </a:r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sv-SE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uality</a:t>
                      </a:r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06099402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illberg</a:t>
                      </a:r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&amp; </a:t>
                      </a:r>
                      <a:r>
                        <a:rPr lang="en-US" sz="900" noProof="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ijer</a:t>
                      </a:r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Karlsson (1983)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9649792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agull &amp; </a:t>
                      </a:r>
                      <a:r>
                        <a:rPr lang="en-US" sz="900" noProof="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heurer</a:t>
                      </a:r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1986)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783126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aun</a:t>
                      </a:r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&amp; Brown (1999)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4094934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hlers-Flint (2002)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6178866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lewellyn et al. (2003)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5389517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Connell et al. (2003)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2384539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lvish et al. (2006)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9981031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Gaw et al. (2007)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9655955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Connell et al. (2011a)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883382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ldman et al. (2012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2917333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merson &amp; </a:t>
                      </a:r>
                      <a:r>
                        <a:rPr lang="sv-SE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igham</a:t>
                      </a:r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2013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1137760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sv-SE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llfritz</a:t>
                      </a:r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2018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7132534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sv-SE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checo</a:t>
                      </a:r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et al. (2021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 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7500896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sv-SE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Connell</a:t>
                      </a:r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et al. (2021a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4564589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sv-SE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Connell</a:t>
                      </a:r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et al. (2021b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531211343"/>
                  </a:ext>
                </a:extLst>
              </a:tr>
              <a:tr h="370840">
                <a:tc gridSpan="16">
                  <a:txBody>
                    <a:bodyPr/>
                    <a:lstStyle/>
                    <a:p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te: Y = </a:t>
                      </a:r>
                      <a:r>
                        <a:rPr lang="sv-SE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s</a:t>
                      </a:r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; N = No; CD = </a:t>
                      </a:r>
                      <a:r>
                        <a:rPr lang="sv-SE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nnot</a:t>
                      </a:r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sv-SE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termine</a:t>
                      </a:r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; NA = Not </a:t>
                      </a:r>
                      <a:r>
                        <a:rPr lang="sv-SE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plicable</a:t>
                      </a:r>
                      <a:endParaRPr lang="sv-SE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900" i="0" baseline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udy quality: </a:t>
                      </a:r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= </a:t>
                      </a:r>
                      <a:r>
                        <a:rPr lang="sv-SE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or</a:t>
                      </a:r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; 2 = Fair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sv-SE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8575858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8826700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 4">
            <a:extLst>
              <a:ext uri="{FF2B5EF4-FFF2-40B4-BE49-F238E27FC236}">
                <a16:creationId xmlns:a16="http://schemas.microsoft.com/office/drawing/2014/main" id="{279B11B5-1C52-744C-B502-FFDC4478F7F2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100128261"/>
              </p:ext>
            </p:extLst>
          </p:nvPr>
        </p:nvGraphicFramePr>
        <p:xfrm>
          <a:off x="505968" y="89300"/>
          <a:ext cx="9418166" cy="29838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524000">
                  <a:extLst>
                    <a:ext uri="{9D8B030D-6E8A-4147-A177-3AD203B41FA5}">
                      <a16:colId xmlns:a16="http://schemas.microsoft.com/office/drawing/2014/main" val="1080027653"/>
                    </a:ext>
                  </a:extLst>
                </a:gridCol>
                <a:gridCol w="548640">
                  <a:extLst>
                    <a:ext uri="{9D8B030D-6E8A-4147-A177-3AD203B41FA5}">
                      <a16:colId xmlns:a16="http://schemas.microsoft.com/office/drawing/2014/main" val="3933771790"/>
                    </a:ext>
                  </a:extLst>
                </a:gridCol>
                <a:gridCol w="560832">
                  <a:extLst>
                    <a:ext uri="{9D8B030D-6E8A-4147-A177-3AD203B41FA5}">
                      <a16:colId xmlns:a16="http://schemas.microsoft.com/office/drawing/2014/main" val="3010879176"/>
                    </a:ext>
                  </a:extLst>
                </a:gridCol>
                <a:gridCol w="573024">
                  <a:extLst>
                    <a:ext uri="{9D8B030D-6E8A-4147-A177-3AD203B41FA5}">
                      <a16:colId xmlns:a16="http://schemas.microsoft.com/office/drawing/2014/main" val="1579781944"/>
                    </a:ext>
                  </a:extLst>
                </a:gridCol>
                <a:gridCol w="585216">
                  <a:extLst>
                    <a:ext uri="{9D8B030D-6E8A-4147-A177-3AD203B41FA5}">
                      <a16:colId xmlns:a16="http://schemas.microsoft.com/office/drawing/2014/main" val="292175835"/>
                    </a:ext>
                  </a:extLst>
                </a:gridCol>
                <a:gridCol w="560832">
                  <a:extLst>
                    <a:ext uri="{9D8B030D-6E8A-4147-A177-3AD203B41FA5}">
                      <a16:colId xmlns:a16="http://schemas.microsoft.com/office/drawing/2014/main" val="1377415389"/>
                    </a:ext>
                  </a:extLst>
                </a:gridCol>
                <a:gridCol w="597408">
                  <a:extLst>
                    <a:ext uri="{9D8B030D-6E8A-4147-A177-3AD203B41FA5}">
                      <a16:colId xmlns:a16="http://schemas.microsoft.com/office/drawing/2014/main" val="353620893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315356964"/>
                    </a:ext>
                  </a:extLst>
                </a:gridCol>
                <a:gridCol w="597408">
                  <a:extLst>
                    <a:ext uri="{9D8B030D-6E8A-4147-A177-3AD203B41FA5}">
                      <a16:colId xmlns:a16="http://schemas.microsoft.com/office/drawing/2014/main" val="293044056"/>
                    </a:ext>
                  </a:extLst>
                </a:gridCol>
                <a:gridCol w="573024">
                  <a:extLst>
                    <a:ext uri="{9D8B030D-6E8A-4147-A177-3AD203B41FA5}">
                      <a16:colId xmlns:a16="http://schemas.microsoft.com/office/drawing/2014/main" val="3527300219"/>
                    </a:ext>
                  </a:extLst>
                </a:gridCol>
                <a:gridCol w="621792">
                  <a:extLst>
                    <a:ext uri="{9D8B030D-6E8A-4147-A177-3AD203B41FA5}">
                      <a16:colId xmlns:a16="http://schemas.microsoft.com/office/drawing/2014/main" val="2571088742"/>
                    </a:ext>
                  </a:extLst>
                </a:gridCol>
                <a:gridCol w="621792">
                  <a:extLst>
                    <a:ext uri="{9D8B030D-6E8A-4147-A177-3AD203B41FA5}">
                      <a16:colId xmlns:a16="http://schemas.microsoft.com/office/drawing/2014/main" val="1049949130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163118114"/>
                    </a:ext>
                  </a:extLst>
                </a:gridCol>
                <a:gridCol w="834998">
                  <a:extLst>
                    <a:ext uri="{9D8B030D-6E8A-4147-A177-3AD203B41FA5}">
                      <a16:colId xmlns:a16="http://schemas.microsoft.com/office/drawing/2014/main" val="1707747465"/>
                    </a:ext>
                  </a:extLst>
                </a:gridCol>
              </a:tblGrid>
              <a:tr h="370840">
                <a:tc gridSpan="14">
                  <a:txBody>
                    <a:bodyPr/>
                    <a:lstStyle/>
                    <a:p>
                      <a:pPr algn="l"/>
                      <a:r>
                        <a:rPr lang="sv-SE" sz="9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pplementary</a:t>
                      </a:r>
                      <a:r>
                        <a:rPr lang="sv-SE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Table S3. </a:t>
                      </a:r>
                      <a:r>
                        <a:rPr lang="sv-SE" sz="900" b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uality</a:t>
                      </a:r>
                      <a:r>
                        <a:rPr lang="sv-SE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sv-SE" sz="900" b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sessment</a:t>
                      </a:r>
                      <a:r>
                        <a:rPr lang="sv-SE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sv-SE" sz="900" b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f</a:t>
                      </a:r>
                      <a:r>
                        <a:rPr lang="sv-SE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sv-SE" sz="900" b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cluded</a:t>
                      </a:r>
                      <a:r>
                        <a:rPr lang="sv-SE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ase-Control Studies.</a:t>
                      </a:r>
                      <a:endParaRPr lang="sv-SE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/>
                      <a:endParaRPr lang="sv-SE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b">
                    <a:lnL w="12700" cmpd="sng">
                      <a:noFill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351817335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udy Author(s) (Year)</a:t>
                      </a: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1</a:t>
                      </a: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2</a:t>
                      </a: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3</a:t>
                      </a: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4</a:t>
                      </a: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5</a:t>
                      </a: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6</a:t>
                      </a: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7</a:t>
                      </a: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8</a:t>
                      </a: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9</a:t>
                      </a: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10</a:t>
                      </a: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11</a:t>
                      </a: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12</a:t>
                      </a: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udy</a:t>
                      </a:r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sv-SE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uality</a:t>
                      </a:r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06099402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noProof="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ymchuk</a:t>
                      </a:r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&amp; </a:t>
                      </a:r>
                      <a:r>
                        <a:rPr lang="en-US" sz="900" noProof="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dron</a:t>
                      </a:r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1990)</a:t>
                      </a:r>
                    </a:p>
                    <a:p>
                      <a:pPr algn="l"/>
                      <a:endParaRPr lang="en-US" sz="900" noProof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9649792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Gaw et al. (2010)</a:t>
                      </a:r>
                    </a:p>
                    <a:p>
                      <a:pPr algn="l"/>
                      <a:endParaRPr lang="en-US" sz="900" noProof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783126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anqvist et al., (2014)</a:t>
                      </a:r>
                    </a:p>
                    <a:p>
                      <a:pPr algn="l"/>
                      <a:endParaRPr lang="en-US" sz="900" noProof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4094934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indberg et al. (2017)</a:t>
                      </a:r>
                    </a:p>
                    <a:p>
                      <a:pPr algn="l"/>
                      <a:endParaRPr lang="en-US" sz="900" noProof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  <a:p>
                      <a:pPr algn="ctr"/>
                      <a:endParaRPr lang="sv-SE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6178866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ammarlund et al., 2021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53895170"/>
                  </a:ext>
                </a:extLst>
              </a:tr>
              <a:tr h="370840">
                <a:tc gridSpan="14">
                  <a:txBody>
                    <a:bodyPr/>
                    <a:lstStyle/>
                    <a:p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te: Y = </a:t>
                      </a:r>
                      <a:r>
                        <a:rPr lang="sv-SE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s</a:t>
                      </a:r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; N = No; CD = </a:t>
                      </a:r>
                      <a:r>
                        <a:rPr lang="sv-SE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nnot</a:t>
                      </a:r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sv-SE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termine</a:t>
                      </a:r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; NA = Not </a:t>
                      </a:r>
                      <a:r>
                        <a:rPr lang="sv-SE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plicable</a:t>
                      </a:r>
                      <a:endParaRPr lang="sv-SE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900" i="0" baseline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udy quality: </a:t>
                      </a:r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= </a:t>
                      </a:r>
                      <a:r>
                        <a:rPr lang="sv-SE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or</a:t>
                      </a:r>
                      <a:r>
                        <a:rPr lang="sv-SE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; 2 = Fair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sv-SE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328575858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087716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292</TotalTime>
  <Words>549</Words>
  <Application>Microsoft Macintosh PowerPoint</Application>
  <PresentationFormat>Bredbild</PresentationFormat>
  <Paragraphs>346</Paragraphs>
  <Slides>2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4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-tema</vt:lpstr>
      <vt:lpstr>PowerPoint-presentation</vt:lpstr>
      <vt:lpstr>PowerPoint-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Mårten Hammarlund</dc:creator>
  <cp:lastModifiedBy>Mårten Hammarlund</cp:lastModifiedBy>
  <cp:revision>109</cp:revision>
  <dcterms:created xsi:type="dcterms:W3CDTF">2021-10-19T11:25:00Z</dcterms:created>
  <dcterms:modified xsi:type="dcterms:W3CDTF">2022-04-22T23:45:46Z</dcterms:modified>
</cp:coreProperties>
</file>